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  <a:srgbClr val="FAFAFA"/>
    <a:srgbClr val="FEFEFE"/>
    <a:srgbClr val="EAEAEA"/>
    <a:srgbClr val="E8E8E8"/>
    <a:srgbClr val="F9F9F9"/>
    <a:srgbClr val="5B9DFF"/>
    <a:srgbClr val="2770A1"/>
    <a:srgbClr val="007AD6"/>
    <a:srgbClr val="00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8" autoAdjust="0"/>
    <p:restoredTop sz="94660"/>
  </p:normalViewPr>
  <p:slideViewPr>
    <p:cSldViewPr snapToGrid="0">
      <p:cViewPr>
        <p:scale>
          <a:sx n="90" d="100"/>
          <a:sy n="90" d="100"/>
        </p:scale>
        <p:origin x="1240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95752-3DE1-49BE-8D6E-278DEC7F61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01E31E-8FA9-42D3-A4CA-854B2AD05D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48E5D-0594-459F-80A1-C3C5FB3E0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46BED0-3BE6-4A61-8205-D6F91C3EF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732EC-91DE-4ED7-BB25-473FE7EF9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888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9EFD1-E094-41F1-AB70-2EB53D81A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219DC5-C354-4893-91BF-67E714CC60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5E6A74-74BF-4CE8-BB78-DBE8D5461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F70AFF-FB80-4CE0-A8E8-515BA8F21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AECAC-6177-4E1A-A72F-308658A91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8231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652AD8-D6B2-45D1-A954-33F59F5D49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2D851A-945E-48DB-AA08-CB60DBA570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092D6D-2F95-4892-9B98-166E9ADD0B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0EF5A-1464-4F36-98C4-EB93D7EE7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2D36A5-DA0C-4FE5-8CBA-F2843E7D8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1744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02A78-A7AB-48EC-AF0A-9B519875EB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740899-F88E-4331-A080-0DA9F8B93F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371FAD-55CA-48C8-BBDA-652322F05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368A04-792A-4ACF-8FA0-922799E9E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B2F414-9E55-43DA-B00F-4DD679B54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8320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51162-2214-49C7-BC42-9C125E5ABC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43F18F-2421-47B1-B0E2-FE5BF47110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4692B-6654-40C9-85A9-4CD46C6A06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B7E90A-0820-4814-850C-680A807BF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08B6B8-5E41-404D-BB03-5C9874D6B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896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AD87B-6DD5-428F-A54E-E5A255C01D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A46DA2-E42A-406B-AB12-C0E9AAA6E3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D44585-A090-43EA-945F-1FA0B046E8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F5E5B8-CFE5-41E1-AAC6-13FEAE205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81B13E-AE27-433D-8875-0538FFDB4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108E3D-2429-463B-B550-8C2061F2B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238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AE68C-0EA5-4E29-B194-2A833D49F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4533FE-6C0D-4BA8-972A-FDCAA5A858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595AF4-E378-40CC-9590-75B9BE7C20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533808-B386-4EE8-A2D1-0710C82A4B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664100-48F6-4198-86D7-C02538C1B1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15F9D9-B96F-4D66-88EF-8FD13D225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2461CF-90F4-44E1-8366-036BB0340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32EEA9-47F6-4D9A-AE70-2D63117B7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3716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7165B2-DD85-4D5C-B234-AAD0EAF68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E6CA9F-60DA-4B02-AD88-B36788141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9B4BD8-2532-4DAE-A8B9-C042E4386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455372-D8DB-42AB-823C-DB5B5235D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3209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209DA1-634A-4C4A-A3E0-DD19D7FB9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96623F-6188-4BBB-975A-B8826C6AD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731FDF-26BE-4672-9A70-EC34413EB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0241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2CE98E-0F2A-467A-A8F8-0553BAB853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774E7B-E4C4-432E-868D-12964B206D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685577-45D5-449E-B7C8-1211C4FE3E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A86DC4-3FEF-4DE8-9651-BCF352D7F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4E79B4-CB61-4975-B27C-218AEFE05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F82F95-1017-499E-AEAE-3369C40C3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5648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87F595-94B3-48C4-81A2-0A5789F1F7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258672-528B-4FAF-883F-8BB3FCDF9B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08917F-D146-4A23-9E44-41AE8D5CBE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BC9F22-B2D9-4BF9-A060-BC1C3422E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E8CDD5-B1E7-434C-A14D-F5DECC113A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5F1254-760E-40ED-8AFB-7FD6BAEC2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2399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91A411-DFD0-4C14-A397-B89E12FBBE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40ABFD-1D85-4F5E-A71A-55EB2B9943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749724-CF50-45BD-B080-DE6BBC74FE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8A38C-EF1A-4CEB-978E-024BEA753FCB}" type="datetimeFigureOut">
              <a:rPr lang="en-GB" smtClean="0"/>
              <a:t>31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822C9A-C67E-4F81-911E-6F87644C53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49EA2E-80DC-4FB1-8435-3891A6EEEC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372C5-0C34-41CE-97AF-F5E76B8402B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908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>
            <a:extLst>
              <a:ext uri="{FF2B5EF4-FFF2-40B4-BE49-F238E27FC236}">
                <a16:creationId xmlns:a16="http://schemas.microsoft.com/office/drawing/2014/main" id="{ED669FA2-7E18-67CE-F3A3-642D23D05233}"/>
              </a:ext>
            </a:extLst>
          </p:cNvPr>
          <p:cNvSpPr txBox="1"/>
          <p:nvPr/>
        </p:nvSpPr>
        <p:spPr>
          <a:xfrm>
            <a:off x="4949339" y="717907"/>
            <a:ext cx="1146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dirty="0" err="1"/>
              <a:t>Ponceau</a:t>
            </a:r>
            <a:r>
              <a:rPr lang="pt-PT" dirty="0"/>
              <a:t> S</a:t>
            </a:r>
          </a:p>
        </p:txBody>
      </p:sp>
      <p:pic>
        <p:nvPicPr>
          <p:cNvPr id="9" name="Picture 46" descr="A black and white photo of a bar of dna&#10;&#10;Description automatically generated">
            <a:extLst>
              <a:ext uri="{FF2B5EF4-FFF2-40B4-BE49-F238E27FC236}">
                <a16:creationId xmlns:a16="http://schemas.microsoft.com/office/drawing/2014/main" id="{0818F412-8E49-1459-9F87-8AA3B11DBF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alphaModFix amt="57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39" t="-918" r="-1397" b="-371"/>
          <a:stretch/>
        </p:blipFill>
        <p:spPr>
          <a:xfrm>
            <a:off x="2891228" y="1725280"/>
            <a:ext cx="5285023" cy="391776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0" name="CaixaDeTexto 9">
            <a:extLst>
              <a:ext uri="{FF2B5EF4-FFF2-40B4-BE49-F238E27FC236}">
                <a16:creationId xmlns:a16="http://schemas.microsoft.com/office/drawing/2014/main" id="{A3897C9B-2C15-B3BF-7825-ABA66E8752B8}"/>
              </a:ext>
            </a:extLst>
          </p:cNvPr>
          <p:cNvSpPr txBox="1"/>
          <p:nvPr/>
        </p:nvSpPr>
        <p:spPr>
          <a:xfrm>
            <a:off x="3443288" y="5057776"/>
            <a:ext cx="3793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dirty="0"/>
              <a:t>Y     Y     Y   A   A    A   A   A    AP  AP   AP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31F19346-6320-8274-938C-DDF5C64CFC59}"/>
              </a:ext>
            </a:extLst>
          </p:cNvPr>
          <p:cNvSpPr txBox="1"/>
          <p:nvPr/>
        </p:nvSpPr>
        <p:spPr>
          <a:xfrm>
            <a:off x="8423901" y="4826943"/>
            <a:ext cx="376809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600" dirty="0"/>
              <a:t>Y – </a:t>
            </a:r>
            <a:r>
              <a:rPr lang="pt-PT" sz="1600" dirty="0" err="1"/>
              <a:t>young</a:t>
            </a:r>
            <a:r>
              <a:rPr lang="pt-PT" sz="1600" dirty="0"/>
              <a:t> </a:t>
            </a:r>
            <a:r>
              <a:rPr lang="pt-PT" sz="1600" dirty="0" err="1"/>
              <a:t>animals</a:t>
            </a:r>
            <a:endParaRPr lang="pt-PT" sz="1600" dirty="0"/>
          </a:p>
          <a:p>
            <a:r>
              <a:rPr lang="pt-PT" sz="1600" dirty="0"/>
              <a:t>A – </a:t>
            </a:r>
            <a:r>
              <a:rPr lang="pt-PT" sz="1600" dirty="0" err="1"/>
              <a:t>reproductively</a:t>
            </a:r>
            <a:r>
              <a:rPr lang="pt-PT" sz="1600" dirty="0"/>
              <a:t> </a:t>
            </a:r>
            <a:r>
              <a:rPr lang="pt-PT" sz="1600" dirty="0" err="1"/>
              <a:t>aged</a:t>
            </a:r>
            <a:r>
              <a:rPr lang="pt-PT" sz="1600" dirty="0"/>
              <a:t> </a:t>
            </a:r>
            <a:r>
              <a:rPr lang="pt-PT" sz="1600" dirty="0" err="1"/>
              <a:t>animals</a:t>
            </a:r>
            <a:endParaRPr lang="pt-PT" sz="1600" dirty="0"/>
          </a:p>
          <a:p>
            <a:r>
              <a:rPr lang="pt-PT" sz="1600" dirty="0"/>
              <a:t>AP – </a:t>
            </a:r>
            <a:r>
              <a:rPr lang="pt-PT" sz="1600" dirty="0" err="1"/>
              <a:t>apocynin</a:t>
            </a:r>
            <a:r>
              <a:rPr lang="pt-PT" sz="1600" dirty="0"/>
              <a:t> </a:t>
            </a:r>
            <a:r>
              <a:rPr lang="pt-PT" sz="1600" dirty="0" err="1"/>
              <a:t>treated</a:t>
            </a:r>
            <a:r>
              <a:rPr lang="pt-PT" sz="1600" dirty="0"/>
              <a:t> </a:t>
            </a:r>
            <a:r>
              <a:rPr lang="pt-PT" sz="1600" dirty="0" err="1"/>
              <a:t>reproductively</a:t>
            </a:r>
            <a:r>
              <a:rPr lang="pt-PT" sz="1600" dirty="0"/>
              <a:t> </a:t>
            </a:r>
            <a:r>
              <a:rPr lang="pt-PT" sz="1600" dirty="0" err="1"/>
              <a:t>aged</a:t>
            </a:r>
            <a:r>
              <a:rPr lang="pt-PT" sz="1600" dirty="0"/>
              <a:t> </a:t>
            </a:r>
            <a:r>
              <a:rPr lang="pt-PT" sz="1600" dirty="0" err="1"/>
              <a:t>animals</a:t>
            </a:r>
            <a:endParaRPr lang="pt-PT" sz="1600" dirty="0"/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FE9FDF2B-7531-F8DA-AFEE-9D3668F3E204}"/>
              </a:ext>
            </a:extLst>
          </p:cNvPr>
          <p:cNvSpPr txBox="1"/>
          <p:nvPr/>
        </p:nvSpPr>
        <p:spPr>
          <a:xfrm>
            <a:off x="3848270" y="6281090"/>
            <a:ext cx="2983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dirty="0" err="1"/>
              <a:t>Membrane</a:t>
            </a:r>
            <a:r>
              <a:rPr lang="pt-PT" dirty="0"/>
              <a:t> </a:t>
            </a:r>
            <a:r>
              <a:rPr lang="pt-PT" dirty="0" err="1"/>
              <a:t>without</a:t>
            </a:r>
            <a:r>
              <a:rPr lang="pt-PT" dirty="0"/>
              <a:t> </a:t>
            </a:r>
            <a:r>
              <a:rPr lang="pt-PT" dirty="0" err="1"/>
              <a:t>cropping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41995669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0192F5-0A57-0ABF-4102-4B48227069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9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7B5FCA2F-076C-149E-71FA-DC61CA41F4B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1" t="-139" r="75" b="-153"/>
          <a:stretch/>
        </p:blipFill>
        <p:spPr>
          <a:xfrm>
            <a:off x="2538394" y="1720279"/>
            <a:ext cx="5433329" cy="407064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42AE634E-EE6E-C31C-AE79-01D3D1600373}"/>
              </a:ext>
            </a:extLst>
          </p:cNvPr>
          <p:cNvSpPr txBox="1"/>
          <p:nvPr/>
        </p:nvSpPr>
        <p:spPr>
          <a:xfrm>
            <a:off x="4731517" y="882410"/>
            <a:ext cx="1047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dirty="0" err="1"/>
              <a:t>IgG</a:t>
            </a:r>
            <a:r>
              <a:rPr lang="pt-PT" dirty="0"/>
              <a:t> - </a:t>
            </a:r>
            <a:r>
              <a:rPr lang="pt-PT" dirty="0" err="1"/>
              <a:t>blot</a:t>
            </a:r>
            <a:endParaRPr lang="pt-PT" dirty="0"/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87629C7B-5338-BA2D-4845-2531177D6F36}"/>
              </a:ext>
            </a:extLst>
          </p:cNvPr>
          <p:cNvSpPr txBox="1"/>
          <p:nvPr/>
        </p:nvSpPr>
        <p:spPr>
          <a:xfrm>
            <a:off x="511944" y="2863613"/>
            <a:ext cx="1852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dirty="0" err="1"/>
              <a:t>IgG</a:t>
            </a:r>
            <a:r>
              <a:rPr lang="pt-PT" dirty="0"/>
              <a:t> – </a:t>
            </a:r>
            <a:r>
              <a:rPr lang="pt-PT" dirty="0" err="1"/>
              <a:t>Heavy</a:t>
            </a:r>
            <a:r>
              <a:rPr lang="pt-PT" dirty="0"/>
              <a:t> </a:t>
            </a:r>
            <a:r>
              <a:rPr lang="pt-PT" dirty="0" err="1"/>
              <a:t>chain</a:t>
            </a:r>
            <a:endParaRPr lang="pt-PT" dirty="0"/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EBB28C7A-758D-3586-7E84-5F98D59624B7}"/>
              </a:ext>
            </a:extLst>
          </p:cNvPr>
          <p:cNvSpPr txBox="1"/>
          <p:nvPr/>
        </p:nvSpPr>
        <p:spPr>
          <a:xfrm>
            <a:off x="3443288" y="5372106"/>
            <a:ext cx="3793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dirty="0"/>
              <a:t>Y     Y     Y   A   A    A   A   A    AP  AP   AP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DAAFC160-6EC6-DD8A-463D-3B0550472BC6}"/>
              </a:ext>
            </a:extLst>
          </p:cNvPr>
          <p:cNvSpPr txBox="1"/>
          <p:nvPr/>
        </p:nvSpPr>
        <p:spPr>
          <a:xfrm>
            <a:off x="8423901" y="4826943"/>
            <a:ext cx="376809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600" dirty="0"/>
              <a:t>Y – </a:t>
            </a:r>
            <a:r>
              <a:rPr lang="pt-PT" sz="1600" dirty="0" err="1"/>
              <a:t>young</a:t>
            </a:r>
            <a:r>
              <a:rPr lang="pt-PT" sz="1600" dirty="0"/>
              <a:t> </a:t>
            </a:r>
            <a:r>
              <a:rPr lang="pt-PT" sz="1600" dirty="0" err="1"/>
              <a:t>animals</a:t>
            </a:r>
            <a:endParaRPr lang="pt-PT" sz="1600" dirty="0"/>
          </a:p>
          <a:p>
            <a:r>
              <a:rPr lang="pt-PT" sz="1600" dirty="0"/>
              <a:t>A – </a:t>
            </a:r>
            <a:r>
              <a:rPr lang="pt-PT" sz="1600" dirty="0" err="1"/>
              <a:t>reproductively</a:t>
            </a:r>
            <a:r>
              <a:rPr lang="pt-PT" sz="1600" dirty="0"/>
              <a:t> </a:t>
            </a:r>
            <a:r>
              <a:rPr lang="pt-PT" sz="1600" dirty="0" err="1"/>
              <a:t>aged</a:t>
            </a:r>
            <a:r>
              <a:rPr lang="pt-PT" sz="1600" dirty="0"/>
              <a:t> </a:t>
            </a:r>
            <a:r>
              <a:rPr lang="pt-PT" sz="1600" dirty="0" err="1"/>
              <a:t>animals</a:t>
            </a:r>
            <a:endParaRPr lang="pt-PT" sz="1600" dirty="0"/>
          </a:p>
          <a:p>
            <a:r>
              <a:rPr lang="pt-PT" sz="1600" dirty="0"/>
              <a:t>AP – </a:t>
            </a:r>
            <a:r>
              <a:rPr lang="pt-PT" sz="1600" dirty="0" err="1"/>
              <a:t>apocynin</a:t>
            </a:r>
            <a:r>
              <a:rPr lang="pt-PT" sz="1600" dirty="0"/>
              <a:t> </a:t>
            </a:r>
            <a:r>
              <a:rPr lang="pt-PT" sz="1600" dirty="0" err="1"/>
              <a:t>treated</a:t>
            </a:r>
            <a:r>
              <a:rPr lang="pt-PT" sz="1600" dirty="0"/>
              <a:t> </a:t>
            </a:r>
            <a:r>
              <a:rPr lang="pt-PT" sz="1600" dirty="0" err="1"/>
              <a:t>reproductively</a:t>
            </a:r>
            <a:r>
              <a:rPr lang="pt-PT" sz="1600" dirty="0"/>
              <a:t> </a:t>
            </a:r>
            <a:r>
              <a:rPr lang="pt-PT" sz="1600" dirty="0" err="1"/>
              <a:t>aged</a:t>
            </a:r>
            <a:r>
              <a:rPr lang="pt-PT" sz="1600" dirty="0"/>
              <a:t> </a:t>
            </a:r>
            <a:r>
              <a:rPr lang="pt-PT" sz="1600" dirty="0" err="1"/>
              <a:t>animals</a:t>
            </a:r>
            <a:endParaRPr lang="pt-PT" sz="1600" dirty="0"/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3A23E0CD-D8CB-A511-DD3F-3BB4511761F3}"/>
              </a:ext>
            </a:extLst>
          </p:cNvPr>
          <p:cNvSpPr txBox="1"/>
          <p:nvPr/>
        </p:nvSpPr>
        <p:spPr>
          <a:xfrm>
            <a:off x="3848270" y="6281090"/>
            <a:ext cx="2983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dirty="0" err="1"/>
              <a:t>Membrane</a:t>
            </a:r>
            <a:r>
              <a:rPr lang="pt-PT" dirty="0"/>
              <a:t> </a:t>
            </a:r>
            <a:r>
              <a:rPr lang="pt-PT" dirty="0" err="1"/>
              <a:t>without</a:t>
            </a:r>
            <a:r>
              <a:rPr lang="pt-PT" dirty="0"/>
              <a:t> </a:t>
            </a:r>
            <a:r>
              <a:rPr lang="pt-PT" dirty="0" err="1"/>
              <a:t>cropping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322943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44</TotalTime>
  <Words>69</Words>
  <Application>Microsoft Macintosh PowerPoint</Application>
  <PresentationFormat>Ecrã Panorâmico</PresentationFormat>
  <Paragraphs>13</Paragraphs>
  <Slides>2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arina Isabel Fonseca Brandão</dc:creator>
  <cp:lastModifiedBy>ELISABETE MOURA</cp:lastModifiedBy>
  <cp:revision>22</cp:revision>
  <dcterms:created xsi:type="dcterms:W3CDTF">2023-10-20T06:31:41Z</dcterms:created>
  <dcterms:modified xsi:type="dcterms:W3CDTF">2025-01-31T11:21:48Z</dcterms:modified>
</cp:coreProperties>
</file>